
<file path=[Content_Types].xml><?xml version="1.0" encoding="utf-8"?>
<Types xmlns="http://schemas.openxmlformats.org/package/2006/content-types">
  <Default Extension="xml" ContentType="application/xml"/>
  <Default Extension="rels" ContentType="application/vnd.openxmlformats-package.relationships+xml"/>
  <Default Extension="jpe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17" autoAdjust="0"/>
    <p:restoredTop sz="94660"/>
  </p:normalViewPr>
  <p:slideViewPr>
    <p:cSldViewPr snapToGrid="0">
      <p:cViewPr varScale="1">
        <p:scale>
          <a:sx n="115" d="100"/>
          <a:sy n="115" d="100"/>
        </p:scale>
        <p:origin x="504"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4" Type="http://schemas.openxmlformats.org/officeDocument/2006/relationships/viewProps" Target="viewProps.xml"/><Relationship Id="rId5" Type="http://schemas.openxmlformats.org/officeDocument/2006/relationships/theme" Target="theme/theme1.xml"/><Relationship Id="rId6"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7D613791-8FBC-4854-96C7-24DAE6EF9244}" type="datetimeFigureOut">
              <a:rPr lang="en-US" smtClean="0"/>
              <a:t>6/23/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DA68C3-00E6-4AC1-B8F3-82EE9FCC7656}" type="slidenum">
              <a:rPr lang="en-US" smtClean="0"/>
              <a:t>‹#›</a:t>
            </a:fld>
            <a:endParaRPr lang="en-US"/>
          </a:p>
        </p:txBody>
      </p:sp>
    </p:spTree>
    <p:extLst>
      <p:ext uri="{BB962C8B-B14F-4D97-AF65-F5344CB8AC3E}">
        <p14:creationId xmlns:p14="http://schemas.microsoft.com/office/powerpoint/2010/main" val="18884021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D613791-8FBC-4854-96C7-24DAE6EF9244}" type="datetimeFigureOut">
              <a:rPr lang="en-US" smtClean="0"/>
              <a:t>6/23/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DA68C3-00E6-4AC1-B8F3-82EE9FCC7656}" type="slidenum">
              <a:rPr lang="en-US" smtClean="0"/>
              <a:t>‹#›</a:t>
            </a:fld>
            <a:endParaRPr lang="en-US"/>
          </a:p>
        </p:txBody>
      </p:sp>
    </p:spTree>
    <p:extLst>
      <p:ext uri="{BB962C8B-B14F-4D97-AF65-F5344CB8AC3E}">
        <p14:creationId xmlns:p14="http://schemas.microsoft.com/office/powerpoint/2010/main" val="34859351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D613791-8FBC-4854-96C7-24DAE6EF9244}" type="datetimeFigureOut">
              <a:rPr lang="en-US" smtClean="0"/>
              <a:t>6/23/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DA68C3-00E6-4AC1-B8F3-82EE9FCC7656}" type="slidenum">
              <a:rPr lang="en-US" smtClean="0"/>
              <a:t>‹#›</a:t>
            </a:fld>
            <a:endParaRPr lang="en-US"/>
          </a:p>
        </p:txBody>
      </p:sp>
    </p:spTree>
    <p:extLst>
      <p:ext uri="{BB962C8B-B14F-4D97-AF65-F5344CB8AC3E}">
        <p14:creationId xmlns:p14="http://schemas.microsoft.com/office/powerpoint/2010/main" val="30166158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D613791-8FBC-4854-96C7-24DAE6EF9244}" type="datetimeFigureOut">
              <a:rPr lang="en-US" smtClean="0"/>
              <a:t>6/23/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DA68C3-00E6-4AC1-B8F3-82EE9FCC7656}" type="slidenum">
              <a:rPr lang="en-US" smtClean="0"/>
              <a:t>‹#›</a:t>
            </a:fld>
            <a:endParaRPr lang="en-US"/>
          </a:p>
        </p:txBody>
      </p:sp>
    </p:spTree>
    <p:extLst>
      <p:ext uri="{BB962C8B-B14F-4D97-AF65-F5344CB8AC3E}">
        <p14:creationId xmlns:p14="http://schemas.microsoft.com/office/powerpoint/2010/main" val="3109410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7D613791-8FBC-4854-96C7-24DAE6EF9244}" type="datetimeFigureOut">
              <a:rPr lang="en-US" smtClean="0"/>
              <a:t>6/23/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DA68C3-00E6-4AC1-B8F3-82EE9FCC7656}" type="slidenum">
              <a:rPr lang="en-US" smtClean="0"/>
              <a:t>‹#›</a:t>
            </a:fld>
            <a:endParaRPr lang="en-US"/>
          </a:p>
        </p:txBody>
      </p:sp>
    </p:spTree>
    <p:extLst>
      <p:ext uri="{BB962C8B-B14F-4D97-AF65-F5344CB8AC3E}">
        <p14:creationId xmlns:p14="http://schemas.microsoft.com/office/powerpoint/2010/main" val="6414122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7D613791-8FBC-4854-96C7-24DAE6EF9244}" type="datetimeFigureOut">
              <a:rPr lang="en-US" smtClean="0"/>
              <a:t>6/23/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DA68C3-00E6-4AC1-B8F3-82EE9FCC7656}" type="slidenum">
              <a:rPr lang="en-US" smtClean="0"/>
              <a:t>‹#›</a:t>
            </a:fld>
            <a:endParaRPr lang="en-US"/>
          </a:p>
        </p:txBody>
      </p:sp>
    </p:spTree>
    <p:extLst>
      <p:ext uri="{BB962C8B-B14F-4D97-AF65-F5344CB8AC3E}">
        <p14:creationId xmlns:p14="http://schemas.microsoft.com/office/powerpoint/2010/main" val="37051928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7D613791-8FBC-4854-96C7-24DAE6EF9244}" type="datetimeFigureOut">
              <a:rPr lang="en-US" smtClean="0"/>
              <a:t>6/23/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5DA68C3-00E6-4AC1-B8F3-82EE9FCC7656}" type="slidenum">
              <a:rPr lang="en-US" smtClean="0"/>
              <a:t>‹#›</a:t>
            </a:fld>
            <a:endParaRPr lang="en-US"/>
          </a:p>
        </p:txBody>
      </p:sp>
    </p:spTree>
    <p:extLst>
      <p:ext uri="{BB962C8B-B14F-4D97-AF65-F5344CB8AC3E}">
        <p14:creationId xmlns:p14="http://schemas.microsoft.com/office/powerpoint/2010/main" val="7529857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7D613791-8FBC-4854-96C7-24DAE6EF9244}" type="datetimeFigureOut">
              <a:rPr lang="en-US" smtClean="0"/>
              <a:t>6/23/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5DA68C3-00E6-4AC1-B8F3-82EE9FCC7656}" type="slidenum">
              <a:rPr lang="en-US" smtClean="0"/>
              <a:t>‹#›</a:t>
            </a:fld>
            <a:endParaRPr lang="en-US"/>
          </a:p>
        </p:txBody>
      </p:sp>
    </p:spTree>
    <p:extLst>
      <p:ext uri="{BB962C8B-B14F-4D97-AF65-F5344CB8AC3E}">
        <p14:creationId xmlns:p14="http://schemas.microsoft.com/office/powerpoint/2010/main" val="21355617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D613791-8FBC-4854-96C7-24DAE6EF9244}" type="datetimeFigureOut">
              <a:rPr lang="en-US" smtClean="0"/>
              <a:t>6/23/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5DA68C3-00E6-4AC1-B8F3-82EE9FCC7656}" type="slidenum">
              <a:rPr lang="en-US" smtClean="0"/>
              <a:t>‹#›</a:t>
            </a:fld>
            <a:endParaRPr lang="en-US"/>
          </a:p>
        </p:txBody>
      </p:sp>
    </p:spTree>
    <p:extLst>
      <p:ext uri="{BB962C8B-B14F-4D97-AF65-F5344CB8AC3E}">
        <p14:creationId xmlns:p14="http://schemas.microsoft.com/office/powerpoint/2010/main" val="1564943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7D613791-8FBC-4854-96C7-24DAE6EF9244}" type="datetimeFigureOut">
              <a:rPr lang="en-US" smtClean="0"/>
              <a:t>6/23/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DA68C3-00E6-4AC1-B8F3-82EE9FCC7656}" type="slidenum">
              <a:rPr lang="en-US" smtClean="0"/>
              <a:t>‹#›</a:t>
            </a:fld>
            <a:endParaRPr lang="en-US"/>
          </a:p>
        </p:txBody>
      </p:sp>
    </p:spTree>
    <p:extLst>
      <p:ext uri="{BB962C8B-B14F-4D97-AF65-F5344CB8AC3E}">
        <p14:creationId xmlns:p14="http://schemas.microsoft.com/office/powerpoint/2010/main" val="22342553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7D613791-8FBC-4854-96C7-24DAE6EF9244}" type="datetimeFigureOut">
              <a:rPr lang="en-US" smtClean="0"/>
              <a:t>6/23/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DA68C3-00E6-4AC1-B8F3-82EE9FCC7656}" type="slidenum">
              <a:rPr lang="en-US" smtClean="0"/>
              <a:t>‹#›</a:t>
            </a:fld>
            <a:endParaRPr lang="en-US"/>
          </a:p>
        </p:txBody>
      </p:sp>
    </p:spTree>
    <p:extLst>
      <p:ext uri="{BB962C8B-B14F-4D97-AF65-F5344CB8AC3E}">
        <p14:creationId xmlns:p14="http://schemas.microsoft.com/office/powerpoint/2010/main" val="4165372747"/>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D613791-8FBC-4854-96C7-24DAE6EF9244}" type="datetimeFigureOut">
              <a:rPr lang="en-US" smtClean="0"/>
              <a:t>6/23/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5DA68C3-00E6-4AC1-B8F3-82EE9FCC7656}" type="slidenum">
              <a:rPr lang="en-US" smtClean="0"/>
              <a:t>‹#›</a:t>
            </a:fld>
            <a:endParaRPr lang="en-US"/>
          </a:p>
        </p:txBody>
      </p:sp>
    </p:spTree>
    <p:extLst>
      <p:ext uri="{BB962C8B-B14F-4D97-AF65-F5344CB8AC3E}">
        <p14:creationId xmlns:p14="http://schemas.microsoft.com/office/powerpoint/2010/main" val="303881529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4" name="Group 63"/>
          <p:cNvGrpSpPr/>
          <p:nvPr/>
        </p:nvGrpSpPr>
        <p:grpSpPr>
          <a:xfrm>
            <a:off x="1987566" y="1139484"/>
            <a:ext cx="8098972" cy="1148526"/>
            <a:chOff x="1987566" y="1139484"/>
            <a:chExt cx="8098972" cy="1148526"/>
          </a:xfrm>
        </p:grpSpPr>
        <p:sp>
          <p:nvSpPr>
            <p:cNvPr id="4" name="Cube 3"/>
            <p:cNvSpPr/>
            <p:nvPr/>
          </p:nvSpPr>
          <p:spPr>
            <a:xfrm>
              <a:off x="1987566" y="1139484"/>
              <a:ext cx="8098972" cy="1148526"/>
            </a:xfrm>
            <a:prstGeom prst="cube">
              <a:avLst>
                <a:gd name="adj" fmla="val 86914"/>
              </a:avLst>
            </a:prstGeom>
            <a:solidFill>
              <a:schemeClr val="bg1">
                <a:lumMod val="6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Oval 4"/>
            <p:cNvSpPr/>
            <p:nvPr/>
          </p:nvSpPr>
          <p:spPr>
            <a:xfrm>
              <a:off x="5232178" y="1505244"/>
              <a:ext cx="1632855" cy="488852"/>
            </a:xfrm>
            <a:prstGeom prst="ellipse">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Oval 6"/>
            <p:cNvSpPr/>
            <p:nvPr/>
          </p:nvSpPr>
          <p:spPr>
            <a:xfrm>
              <a:off x="7399607" y="1587891"/>
              <a:ext cx="717452" cy="323557"/>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Oval 7"/>
            <p:cNvSpPr/>
            <p:nvPr/>
          </p:nvSpPr>
          <p:spPr>
            <a:xfrm>
              <a:off x="3980152" y="1587891"/>
              <a:ext cx="717452" cy="323557"/>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0" name="Curved Connector 9"/>
            <p:cNvCxnSpPr/>
            <p:nvPr/>
          </p:nvCxnSpPr>
          <p:spPr>
            <a:xfrm>
              <a:off x="4789211" y="1516552"/>
              <a:ext cx="365760" cy="91440"/>
            </a:xfrm>
            <a:prstGeom prst="curved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 name="Curved Connector 10"/>
            <p:cNvCxnSpPr/>
            <p:nvPr/>
          </p:nvCxnSpPr>
          <p:spPr>
            <a:xfrm>
              <a:off x="4789211" y="1617704"/>
              <a:ext cx="365760" cy="91440"/>
            </a:xfrm>
            <a:prstGeom prst="curved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 name="Curved Connector 11"/>
            <p:cNvCxnSpPr/>
            <p:nvPr/>
          </p:nvCxnSpPr>
          <p:spPr>
            <a:xfrm>
              <a:off x="4774810" y="1718856"/>
              <a:ext cx="365760" cy="91440"/>
            </a:xfrm>
            <a:prstGeom prst="curved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 name="Curved Connector 12"/>
            <p:cNvCxnSpPr/>
            <p:nvPr/>
          </p:nvCxnSpPr>
          <p:spPr>
            <a:xfrm>
              <a:off x="4774810" y="1820008"/>
              <a:ext cx="365760" cy="91440"/>
            </a:xfrm>
            <a:prstGeom prst="curved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 name="Curved Connector 17"/>
            <p:cNvCxnSpPr/>
            <p:nvPr/>
          </p:nvCxnSpPr>
          <p:spPr>
            <a:xfrm rot="10800000">
              <a:off x="6971042" y="1526264"/>
              <a:ext cx="365760" cy="91440"/>
            </a:xfrm>
            <a:prstGeom prst="curved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9" name="Curved Connector 18"/>
            <p:cNvCxnSpPr/>
            <p:nvPr/>
          </p:nvCxnSpPr>
          <p:spPr>
            <a:xfrm rot="10800000">
              <a:off x="6971042" y="1627416"/>
              <a:ext cx="365760" cy="91440"/>
            </a:xfrm>
            <a:prstGeom prst="curved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 name="Curved Connector 19"/>
            <p:cNvCxnSpPr/>
            <p:nvPr/>
          </p:nvCxnSpPr>
          <p:spPr>
            <a:xfrm rot="10800000">
              <a:off x="6956641" y="1728568"/>
              <a:ext cx="365760" cy="91440"/>
            </a:xfrm>
            <a:prstGeom prst="curved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 name="Curved Connector 20"/>
            <p:cNvCxnSpPr/>
            <p:nvPr/>
          </p:nvCxnSpPr>
          <p:spPr>
            <a:xfrm rot="10800000">
              <a:off x="6956641" y="1829719"/>
              <a:ext cx="365760" cy="91440"/>
            </a:xfrm>
            <a:prstGeom prst="curved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3" name="Cube 22"/>
            <p:cNvSpPr/>
            <p:nvPr/>
          </p:nvSpPr>
          <p:spPr>
            <a:xfrm>
              <a:off x="3305908" y="1315248"/>
              <a:ext cx="5753686" cy="787791"/>
            </a:xfrm>
            <a:prstGeom prst="cube">
              <a:avLst>
                <a:gd name="adj" fmla="val 100000"/>
              </a:avLst>
            </a:prstGeom>
            <a:solidFill>
              <a:schemeClr val="accent4">
                <a:lumMod val="20000"/>
                <a:lumOff val="80000"/>
                <a:alpha val="17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TextBox 23"/>
            <p:cNvSpPr txBox="1"/>
            <p:nvPr/>
          </p:nvSpPr>
          <p:spPr>
            <a:xfrm>
              <a:off x="5779353" y="1543902"/>
              <a:ext cx="603050" cy="369332"/>
            </a:xfrm>
            <a:prstGeom prst="rect">
              <a:avLst/>
            </a:prstGeom>
            <a:noFill/>
          </p:spPr>
          <p:txBody>
            <a:bodyPr wrap="none" rtlCol="0">
              <a:spAutoFit/>
            </a:bodyPr>
            <a:lstStyle/>
            <a:p>
              <a:r>
                <a:rPr lang="en-GB" dirty="0" smtClean="0"/>
                <a:t>BY-2</a:t>
              </a:r>
              <a:endParaRPr lang="en-US" dirty="0"/>
            </a:p>
          </p:txBody>
        </p:sp>
        <p:sp>
          <p:nvSpPr>
            <p:cNvPr id="25" name="TextBox 24"/>
            <p:cNvSpPr txBox="1"/>
            <p:nvPr/>
          </p:nvSpPr>
          <p:spPr>
            <a:xfrm>
              <a:off x="2242959" y="1797986"/>
              <a:ext cx="917239" cy="307777"/>
            </a:xfrm>
            <a:prstGeom prst="rect">
              <a:avLst/>
            </a:prstGeom>
            <a:noFill/>
          </p:spPr>
          <p:txBody>
            <a:bodyPr wrap="none" rtlCol="0">
              <a:spAutoFit/>
            </a:bodyPr>
            <a:lstStyle/>
            <a:p>
              <a:r>
                <a:rPr lang="en-GB" sz="1400" dirty="0"/>
                <a:t>g</a:t>
              </a:r>
              <a:r>
                <a:rPr lang="en-GB" sz="1400" dirty="0" smtClean="0"/>
                <a:t>lass </a:t>
              </a:r>
              <a:r>
                <a:rPr lang="en-GB" sz="1400" dirty="0"/>
                <a:t>s</a:t>
              </a:r>
              <a:r>
                <a:rPr lang="en-GB" sz="1400" dirty="0" smtClean="0"/>
                <a:t>lide</a:t>
              </a:r>
              <a:endParaRPr lang="en-US" sz="1400" dirty="0"/>
            </a:p>
          </p:txBody>
        </p:sp>
        <p:sp>
          <p:nvSpPr>
            <p:cNvPr id="26" name="TextBox 25"/>
            <p:cNvSpPr txBox="1"/>
            <p:nvPr/>
          </p:nvSpPr>
          <p:spPr>
            <a:xfrm>
              <a:off x="8025282" y="1264207"/>
              <a:ext cx="830035" cy="307777"/>
            </a:xfrm>
            <a:prstGeom prst="rect">
              <a:avLst/>
            </a:prstGeom>
            <a:noFill/>
          </p:spPr>
          <p:txBody>
            <a:bodyPr wrap="none" rtlCol="0">
              <a:spAutoFit/>
            </a:bodyPr>
            <a:lstStyle/>
            <a:p>
              <a:r>
                <a:rPr lang="en-GB" sz="1400" dirty="0"/>
                <a:t>c</a:t>
              </a:r>
              <a:r>
                <a:rPr lang="en-GB" sz="1400" dirty="0" smtClean="0"/>
                <a:t>overslip</a:t>
              </a:r>
              <a:endParaRPr lang="en-US" sz="1400" dirty="0"/>
            </a:p>
          </p:txBody>
        </p:sp>
      </p:grpSp>
      <p:grpSp>
        <p:nvGrpSpPr>
          <p:cNvPr id="63" name="Group 62"/>
          <p:cNvGrpSpPr/>
          <p:nvPr/>
        </p:nvGrpSpPr>
        <p:grpSpPr>
          <a:xfrm>
            <a:off x="960622" y="2946512"/>
            <a:ext cx="8098972" cy="1148526"/>
            <a:chOff x="1959430" y="3830685"/>
            <a:chExt cx="8098972" cy="1148526"/>
          </a:xfrm>
        </p:grpSpPr>
        <p:sp>
          <p:nvSpPr>
            <p:cNvPr id="47" name="Cube 46"/>
            <p:cNvSpPr/>
            <p:nvPr/>
          </p:nvSpPr>
          <p:spPr>
            <a:xfrm>
              <a:off x="1959430" y="3830685"/>
              <a:ext cx="8098972" cy="1148526"/>
            </a:xfrm>
            <a:prstGeom prst="cube">
              <a:avLst>
                <a:gd name="adj" fmla="val 86914"/>
              </a:avLst>
            </a:prstGeom>
            <a:solidFill>
              <a:schemeClr val="bg1">
                <a:lumMod val="6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Oval 48"/>
            <p:cNvSpPr/>
            <p:nvPr/>
          </p:nvSpPr>
          <p:spPr>
            <a:xfrm>
              <a:off x="7371471" y="4279092"/>
              <a:ext cx="717452" cy="323557"/>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Oval 49"/>
            <p:cNvSpPr/>
            <p:nvPr/>
          </p:nvSpPr>
          <p:spPr>
            <a:xfrm>
              <a:off x="3952016" y="4279092"/>
              <a:ext cx="717452" cy="323557"/>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1" name="Curved Connector 50"/>
            <p:cNvCxnSpPr/>
            <p:nvPr/>
          </p:nvCxnSpPr>
          <p:spPr>
            <a:xfrm>
              <a:off x="4761075" y="4207753"/>
              <a:ext cx="365760" cy="91440"/>
            </a:xfrm>
            <a:prstGeom prst="curved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2" name="Curved Connector 51"/>
            <p:cNvCxnSpPr/>
            <p:nvPr/>
          </p:nvCxnSpPr>
          <p:spPr>
            <a:xfrm>
              <a:off x="4761075" y="4308905"/>
              <a:ext cx="365760" cy="91440"/>
            </a:xfrm>
            <a:prstGeom prst="curved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3" name="Curved Connector 52"/>
            <p:cNvCxnSpPr/>
            <p:nvPr/>
          </p:nvCxnSpPr>
          <p:spPr>
            <a:xfrm>
              <a:off x="4746674" y="4410057"/>
              <a:ext cx="365760" cy="91440"/>
            </a:xfrm>
            <a:prstGeom prst="curved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4" name="Curved Connector 53"/>
            <p:cNvCxnSpPr/>
            <p:nvPr/>
          </p:nvCxnSpPr>
          <p:spPr>
            <a:xfrm>
              <a:off x="4746674" y="4511209"/>
              <a:ext cx="365760" cy="91440"/>
            </a:xfrm>
            <a:prstGeom prst="curved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5" name="Curved Connector 54"/>
            <p:cNvCxnSpPr/>
            <p:nvPr/>
          </p:nvCxnSpPr>
          <p:spPr>
            <a:xfrm rot="10800000">
              <a:off x="6942906" y="4217465"/>
              <a:ext cx="365760" cy="91440"/>
            </a:xfrm>
            <a:prstGeom prst="curved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6" name="Curved Connector 55"/>
            <p:cNvCxnSpPr/>
            <p:nvPr/>
          </p:nvCxnSpPr>
          <p:spPr>
            <a:xfrm rot="10800000">
              <a:off x="6942906" y="4318617"/>
              <a:ext cx="365760" cy="91440"/>
            </a:xfrm>
            <a:prstGeom prst="curved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7" name="Curved Connector 56"/>
            <p:cNvCxnSpPr/>
            <p:nvPr/>
          </p:nvCxnSpPr>
          <p:spPr>
            <a:xfrm rot="10800000">
              <a:off x="6928505" y="4419769"/>
              <a:ext cx="365760" cy="91440"/>
            </a:xfrm>
            <a:prstGeom prst="curved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8" name="Curved Connector 57"/>
            <p:cNvCxnSpPr/>
            <p:nvPr/>
          </p:nvCxnSpPr>
          <p:spPr>
            <a:xfrm rot="10800000">
              <a:off x="6928505" y="4520920"/>
              <a:ext cx="365760" cy="91440"/>
            </a:xfrm>
            <a:prstGeom prst="curvedConnector3">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9" name="Cube 58"/>
            <p:cNvSpPr/>
            <p:nvPr/>
          </p:nvSpPr>
          <p:spPr>
            <a:xfrm>
              <a:off x="3277772" y="3994012"/>
              <a:ext cx="5753686" cy="787791"/>
            </a:xfrm>
            <a:prstGeom prst="cube">
              <a:avLst>
                <a:gd name="adj" fmla="val 100000"/>
              </a:avLst>
            </a:prstGeom>
            <a:solidFill>
              <a:schemeClr val="accent4">
                <a:lumMod val="20000"/>
                <a:lumOff val="80000"/>
                <a:alpha val="17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 name="TextBox 60"/>
            <p:cNvSpPr txBox="1"/>
            <p:nvPr/>
          </p:nvSpPr>
          <p:spPr>
            <a:xfrm>
              <a:off x="2214823" y="4489187"/>
              <a:ext cx="917239" cy="307777"/>
            </a:xfrm>
            <a:prstGeom prst="rect">
              <a:avLst/>
            </a:prstGeom>
            <a:noFill/>
          </p:spPr>
          <p:txBody>
            <a:bodyPr wrap="none" rtlCol="0">
              <a:spAutoFit/>
            </a:bodyPr>
            <a:lstStyle/>
            <a:p>
              <a:r>
                <a:rPr lang="en-GB" sz="1400" dirty="0"/>
                <a:t>g</a:t>
              </a:r>
              <a:r>
                <a:rPr lang="en-GB" sz="1400" dirty="0" smtClean="0"/>
                <a:t>lass </a:t>
              </a:r>
              <a:r>
                <a:rPr lang="en-GB" sz="1400" dirty="0"/>
                <a:t>s</a:t>
              </a:r>
              <a:r>
                <a:rPr lang="en-GB" sz="1400" dirty="0" smtClean="0"/>
                <a:t>lide</a:t>
              </a:r>
              <a:endParaRPr lang="en-US" sz="1400" dirty="0"/>
            </a:p>
          </p:txBody>
        </p:sp>
        <p:sp>
          <p:nvSpPr>
            <p:cNvPr id="62" name="TextBox 61"/>
            <p:cNvSpPr txBox="1"/>
            <p:nvPr/>
          </p:nvSpPr>
          <p:spPr>
            <a:xfrm>
              <a:off x="7997146" y="3955408"/>
              <a:ext cx="830035" cy="307777"/>
            </a:xfrm>
            <a:prstGeom prst="rect">
              <a:avLst/>
            </a:prstGeom>
            <a:noFill/>
          </p:spPr>
          <p:txBody>
            <a:bodyPr wrap="none" rtlCol="0">
              <a:spAutoFit/>
            </a:bodyPr>
            <a:lstStyle/>
            <a:p>
              <a:r>
                <a:rPr lang="en-GB" sz="1400" dirty="0"/>
                <a:t>c</a:t>
              </a:r>
              <a:r>
                <a:rPr lang="en-GB" sz="1400" dirty="0" smtClean="0"/>
                <a:t>overslip</a:t>
              </a:r>
              <a:endParaRPr lang="en-US" sz="1400" dirty="0"/>
            </a:p>
          </p:txBody>
        </p:sp>
        <p:grpSp>
          <p:nvGrpSpPr>
            <p:cNvPr id="43" name="Group 42"/>
            <p:cNvGrpSpPr/>
            <p:nvPr/>
          </p:nvGrpSpPr>
          <p:grpSpPr>
            <a:xfrm>
              <a:off x="5473210" y="4104936"/>
              <a:ext cx="885502" cy="610242"/>
              <a:chOff x="5501230" y="617004"/>
              <a:chExt cx="1765108" cy="1807970"/>
            </a:xfrm>
            <a:solidFill>
              <a:schemeClr val="bg1">
                <a:lumMod val="65000"/>
              </a:schemeClr>
            </a:solidFill>
          </p:grpSpPr>
          <p:sp>
            <p:nvSpPr>
              <p:cNvPr id="44" name="Teardrop 43"/>
              <p:cNvSpPr/>
              <p:nvPr/>
            </p:nvSpPr>
            <p:spPr>
              <a:xfrm>
                <a:off x="5501230" y="891665"/>
                <a:ext cx="772961" cy="299804"/>
              </a:xfrm>
              <a:prstGeom prst="teardrop">
                <a:avLst>
                  <a:gd name="adj" fmla="val 133629"/>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Teardrop 44"/>
              <p:cNvSpPr/>
              <p:nvPr/>
            </p:nvSpPr>
            <p:spPr>
              <a:xfrm rot="11424698">
                <a:off x="6493377" y="617004"/>
                <a:ext cx="772961" cy="299804"/>
              </a:xfrm>
              <a:prstGeom prst="teardrop">
                <a:avLst>
                  <a:gd name="adj" fmla="val 133629"/>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Freeform 45"/>
              <p:cNvSpPr/>
              <p:nvPr/>
            </p:nvSpPr>
            <p:spPr>
              <a:xfrm>
                <a:off x="6334025" y="877597"/>
                <a:ext cx="659129" cy="1547377"/>
              </a:xfrm>
              <a:custGeom>
                <a:avLst/>
                <a:gdLst>
                  <a:gd name="connsiteX0" fmla="*/ 140677 w 998806"/>
                  <a:gd name="connsiteY0" fmla="*/ 0 h 2250831"/>
                  <a:gd name="connsiteX1" fmla="*/ 56271 w 998806"/>
                  <a:gd name="connsiteY1" fmla="*/ 14068 h 2250831"/>
                  <a:gd name="connsiteX2" fmla="*/ 14067 w 998806"/>
                  <a:gd name="connsiteY2" fmla="*/ 28135 h 2250831"/>
                  <a:gd name="connsiteX3" fmla="*/ 0 w 998806"/>
                  <a:gd name="connsiteY3" fmla="*/ 70338 h 2250831"/>
                  <a:gd name="connsiteX4" fmla="*/ 42203 w 998806"/>
                  <a:gd name="connsiteY4" fmla="*/ 267286 h 2250831"/>
                  <a:gd name="connsiteX5" fmla="*/ 112541 w 998806"/>
                  <a:gd name="connsiteY5" fmla="*/ 337625 h 2250831"/>
                  <a:gd name="connsiteX6" fmla="*/ 140677 w 998806"/>
                  <a:gd name="connsiteY6" fmla="*/ 365760 h 2250831"/>
                  <a:gd name="connsiteX7" fmla="*/ 182880 w 998806"/>
                  <a:gd name="connsiteY7" fmla="*/ 393895 h 2250831"/>
                  <a:gd name="connsiteX8" fmla="*/ 253218 w 998806"/>
                  <a:gd name="connsiteY8" fmla="*/ 436098 h 2250831"/>
                  <a:gd name="connsiteX9" fmla="*/ 281354 w 998806"/>
                  <a:gd name="connsiteY9" fmla="*/ 478301 h 2250831"/>
                  <a:gd name="connsiteX10" fmla="*/ 309489 w 998806"/>
                  <a:gd name="connsiteY10" fmla="*/ 506437 h 2250831"/>
                  <a:gd name="connsiteX11" fmla="*/ 323557 w 998806"/>
                  <a:gd name="connsiteY11" fmla="*/ 548640 h 2250831"/>
                  <a:gd name="connsiteX12" fmla="*/ 351692 w 998806"/>
                  <a:gd name="connsiteY12" fmla="*/ 590843 h 2250831"/>
                  <a:gd name="connsiteX13" fmla="*/ 379827 w 998806"/>
                  <a:gd name="connsiteY13" fmla="*/ 675249 h 2250831"/>
                  <a:gd name="connsiteX14" fmla="*/ 365760 w 998806"/>
                  <a:gd name="connsiteY14" fmla="*/ 717452 h 2250831"/>
                  <a:gd name="connsiteX15" fmla="*/ 337624 w 998806"/>
                  <a:gd name="connsiteY15" fmla="*/ 858129 h 2250831"/>
                  <a:gd name="connsiteX16" fmla="*/ 379827 w 998806"/>
                  <a:gd name="connsiteY16" fmla="*/ 970671 h 2250831"/>
                  <a:gd name="connsiteX17" fmla="*/ 422031 w 998806"/>
                  <a:gd name="connsiteY17" fmla="*/ 1041009 h 2250831"/>
                  <a:gd name="connsiteX18" fmla="*/ 478301 w 998806"/>
                  <a:gd name="connsiteY18" fmla="*/ 1069145 h 2250831"/>
                  <a:gd name="connsiteX19" fmla="*/ 590843 w 998806"/>
                  <a:gd name="connsiteY19" fmla="*/ 1153551 h 2250831"/>
                  <a:gd name="connsiteX20" fmla="*/ 618978 w 998806"/>
                  <a:gd name="connsiteY20" fmla="*/ 1195754 h 2250831"/>
                  <a:gd name="connsiteX21" fmla="*/ 647114 w 998806"/>
                  <a:gd name="connsiteY21" fmla="*/ 1294228 h 2250831"/>
                  <a:gd name="connsiteX22" fmla="*/ 661181 w 998806"/>
                  <a:gd name="connsiteY22" fmla="*/ 1336431 h 2250831"/>
                  <a:gd name="connsiteX23" fmla="*/ 689317 w 998806"/>
                  <a:gd name="connsiteY23" fmla="*/ 1702191 h 2250831"/>
                  <a:gd name="connsiteX24" fmla="*/ 717452 w 998806"/>
                  <a:gd name="connsiteY24" fmla="*/ 1758461 h 2250831"/>
                  <a:gd name="connsiteX25" fmla="*/ 872197 w 998806"/>
                  <a:gd name="connsiteY25" fmla="*/ 1885071 h 2250831"/>
                  <a:gd name="connsiteX26" fmla="*/ 914400 w 998806"/>
                  <a:gd name="connsiteY26" fmla="*/ 1913206 h 2250831"/>
                  <a:gd name="connsiteX27" fmla="*/ 942535 w 998806"/>
                  <a:gd name="connsiteY27" fmla="*/ 1955409 h 2250831"/>
                  <a:gd name="connsiteX28" fmla="*/ 970671 w 998806"/>
                  <a:gd name="connsiteY28" fmla="*/ 2067951 h 2250831"/>
                  <a:gd name="connsiteX29" fmla="*/ 984738 w 998806"/>
                  <a:gd name="connsiteY29" fmla="*/ 2208628 h 2250831"/>
                  <a:gd name="connsiteX30" fmla="*/ 998806 w 998806"/>
                  <a:gd name="connsiteY30" fmla="*/ 2250831 h 225083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Lst>
                <a:rect l="l" t="t" r="r" b="b"/>
                <a:pathLst>
                  <a:path w="998806" h="2250831">
                    <a:moveTo>
                      <a:pt x="140677" y="0"/>
                    </a:moveTo>
                    <a:cubicBezTo>
                      <a:pt x="112542" y="4689"/>
                      <a:pt x="84115" y="7881"/>
                      <a:pt x="56271" y="14068"/>
                    </a:cubicBezTo>
                    <a:cubicBezTo>
                      <a:pt x="41795" y="17285"/>
                      <a:pt x="24553" y="17649"/>
                      <a:pt x="14067" y="28135"/>
                    </a:cubicBezTo>
                    <a:cubicBezTo>
                      <a:pt x="3582" y="38620"/>
                      <a:pt x="4689" y="56270"/>
                      <a:pt x="0" y="70338"/>
                    </a:cubicBezTo>
                    <a:cubicBezTo>
                      <a:pt x="3145" y="95498"/>
                      <a:pt x="13565" y="238648"/>
                      <a:pt x="42203" y="267286"/>
                    </a:cubicBezTo>
                    <a:lnTo>
                      <a:pt x="112541" y="337625"/>
                    </a:lnTo>
                    <a:cubicBezTo>
                      <a:pt x="121920" y="347004"/>
                      <a:pt x="129641" y="358403"/>
                      <a:pt x="140677" y="365760"/>
                    </a:cubicBezTo>
                    <a:cubicBezTo>
                      <a:pt x="154745" y="375138"/>
                      <a:pt x="169678" y="383333"/>
                      <a:pt x="182880" y="393895"/>
                    </a:cubicBezTo>
                    <a:cubicBezTo>
                      <a:pt x="238053" y="438034"/>
                      <a:pt x="179926" y="411668"/>
                      <a:pt x="253218" y="436098"/>
                    </a:cubicBezTo>
                    <a:cubicBezTo>
                      <a:pt x="262597" y="450166"/>
                      <a:pt x="270792" y="465099"/>
                      <a:pt x="281354" y="478301"/>
                    </a:cubicBezTo>
                    <a:cubicBezTo>
                      <a:pt x="289639" y="488658"/>
                      <a:pt x="302665" y="495064"/>
                      <a:pt x="309489" y="506437"/>
                    </a:cubicBezTo>
                    <a:cubicBezTo>
                      <a:pt x="317118" y="519153"/>
                      <a:pt x="316925" y="535377"/>
                      <a:pt x="323557" y="548640"/>
                    </a:cubicBezTo>
                    <a:cubicBezTo>
                      <a:pt x="331118" y="563762"/>
                      <a:pt x="344825" y="575393"/>
                      <a:pt x="351692" y="590843"/>
                    </a:cubicBezTo>
                    <a:cubicBezTo>
                      <a:pt x="363737" y="617944"/>
                      <a:pt x="379827" y="675249"/>
                      <a:pt x="379827" y="675249"/>
                    </a:cubicBezTo>
                    <a:cubicBezTo>
                      <a:pt x="375138" y="689317"/>
                      <a:pt x="369094" y="703003"/>
                      <a:pt x="365760" y="717452"/>
                    </a:cubicBezTo>
                    <a:cubicBezTo>
                      <a:pt x="355007" y="764048"/>
                      <a:pt x="337624" y="858129"/>
                      <a:pt x="337624" y="858129"/>
                    </a:cubicBezTo>
                    <a:cubicBezTo>
                      <a:pt x="364765" y="993834"/>
                      <a:pt x="331529" y="874075"/>
                      <a:pt x="379827" y="970671"/>
                    </a:cubicBezTo>
                    <a:cubicBezTo>
                      <a:pt x="400991" y="1013000"/>
                      <a:pt x="380814" y="1013531"/>
                      <a:pt x="422031" y="1041009"/>
                    </a:cubicBezTo>
                    <a:cubicBezTo>
                      <a:pt x="439480" y="1052642"/>
                      <a:pt x="460319" y="1058356"/>
                      <a:pt x="478301" y="1069145"/>
                    </a:cubicBezTo>
                    <a:cubicBezTo>
                      <a:pt x="512921" y="1089917"/>
                      <a:pt x="562654" y="1118314"/>
                      <a:pt x="590843" y="1153551"/>
                    </a:cubicBezTo>
                    <a:cubicBezTo>
                      <a:pt x="601405" y="1166753"/>
                      <a:pt x="611417" y="1180632"/>
                      <a:pt x="618978" y="1195754"/>
                    </a:cubicBezTo>
                    <a:cubicBezTo>
                      <a:pt x="630222" y="1218241"/>
                      <a:pt x="641104" y="1273193"/>
                      <a:pt x="647114" y="1294228"/>
                    </a:cubicBezTo>
                    <a:cubicBezTo>
                      <a:pt x="651188" y="1308486"/>
                      <a:pt x="656492" y="1322363"/>
                      <a:pt x="661181" y="1336431"/>
                    </a:cubicBezTo>
                    <a:cubicBezTo>
                      <a:pt x="664573" y="1414441"/>
                      <a:pt x="642665" y="1593337"/>
                      <a:pt x="689317" y="1702191"/>
                    </a:cubicBezTo>
                    <a:cubicBezTo>
                      <a:pt x="697578" y="1721466"/>
                      <a:pt x="704577" y="1741908"/>
                      <a:pt x="717452" y="1758461"/>
                    </a:cubicBezTo>
                    <a:cubicBezTo>
                      <a:pt x="768201" y="1823710"/>
                      <a:pt x="804563" y="1839982"/>
                      <a:pt x="872197" y="1885071"/>
                    </a:cubicBezTo>
                    <a:lnTo>
                      <a:pt x="914400" y="1913206"/>
                    </a:lnTo>
                    <a:cubicBezTo>
                      <a:pt x="923778" y="1927274"/>
                      <a:pt x="934974" y="1940287"/>
                      <a:pt x="942535" y="1955409"/>
                    </a:cubicBezTo>
                    <a:cubicBezTo>
                      <a:pt x="956955" y="1984249"/>
                      <a:pt x="965320" y="2041195"/>
                      <a:pt x="970671" y="2067951"/>
                    </a:cubicBezTo>
                    <a:cubicBezTo>
                      <a:pt x="975360" y="2114843"/>
                      <a:pt x="977572" y="2162050"/>
                      <a:pt x="984738" y="2208628"/>
                    </a:cubicBezTo>
                    <a:cubicBezTo>
                      <a:pt x="986993" y="2223284"/>
                      <a:pt x="998806" y="2250831"/>
                      <a:pt x="998806" y="2250831"/>
                    </a:cubicBezTo>
                  </a:path>
                </a:pathLst>
              </a:custGeom>
              <a:grpFill/>
              <a:ln w="254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sp>
        <p:nvSpPr>
          <p:cNvPr id="65" name="TextBox 64"/>
          <p:cNvSpPr txBox="1"/>
          <p:nvPr/>
        </p:nvSpPr>
        <p:spPr>
          <a:xfrm>
            <a:off x="1860862" y="1048763"/>
            <a:ext cx="370614" cy="461665"/>
          </a:xfrm>
          <a:prstGeom prst="rect">
            <a:avLst/>
          </a:prstGeom>
          <a:noFill/>
        </p:spPr>
        <p:txBody>
          <a:bodyPr wrap="none" rtlCol="0">
            <a:spAutoFit/>
          </a:bodyPr>
          <a:lstStyle/>
          <a:p>
            <a:r>
              <a:rPr lang="en-GB" sz="2400" b="1" dirty="0" smtClean="0"/>
              <a:t>A</a:t>
            </a:r>
            <a:endParaRPr lang="en-US" sz="2400" b="1" dirty="0"/>
          </a:p>
        </p:txBody>
      </p:sp>
      <p:sp>
        <p:nvSpPr>
          <p:cNvPr id="66" name="TextBox 65"/>
          <p:cNvSpPr txBox="1"/>
          <p:nvPr/>
        </p:nvSpPr>
        <p:spPr>
          <a:xfrm>
            <a:off x="874672" y="2863050"/>
            <a:ext cx="357790" cy="461665"/>
          </a:xfrm>
          <a:prstGeom prst="rect">
            <a:avLst/>
          </a:prstGeom>
          <a:noFill/>
        </p:spPr>
        <p:txBody>
          <a:bodyPr wrap="none" rtlCol="0">
            <a:spAutoFit/>
          </a:bodyPr>
          <a:lstStyle/>
          <a:p>
            <a:r>
              <a:rPr lang="en-GB" sz="2400" b="1" dirty="0" smtClean="0"/>
              <a:t>B</a:t>
            </a:r>
            <a:endParaRPr lang="en-US" sz="2400" b="1" dirty="0"/>
          </a:p>
        </p:txBody>
      </p:sp>
      <p:sp>
        <p:nvSpPr>
          <p:cNvPr id="67" name="TextBox 66"/>
          <p:cNvSpPr txBox="1"/>
          <p:nvPr/>
        </p:nvSpPr>
        <p:spPr>
          <a:xfrm>
            <a:off x="842890" y="5078437"/>
            <a:ext cx="8595360" cy="1200329"/>
          </a:xfrm>
          <a:prstGeom prst="rect">
            <a:avLst/>
          </a:prstGeom>
          <a:noFill/>
        </p:spPr>
        <p:txBody>
          <a:bodyPr wrap="square" rtlCol="0">
            <a:spAutoFit/>
          </a:bodyPr>
          <a:lstStyle/>
          <a:p>
            <a:r>
              <a:rPr lang="en-US" b="1" dirty="0" err="1" smtClean="0"/>
              <a:t>Suppl</a:t>
            </a:r>
            <a:r>
              <a:rPr lang="en-US" b="1" dirty="0" smtClean="0"/>
              <a:t> Fig 4</a:t>
            </a:r>
            <a:r>
              <a:rPr lang="en-US" dirty="0" smtClean="0"/>
              <a:t>: Diagrammatic representation of the treatment of (a) BY2 cells and (b) </a:t>
            </a:r>
            <a:r>
              <a:rPr lang="en-US" i="1" dirty="0" smtClean="0"/>
              <a:t>Arabidopsis </a:t>
            </a:r>
            <a:r>
              <a:rPr lang="en-US" i="1" smtClean="0"/>
              <a:t>thaliana</a:t>
            </a:r>
            <a:r>
              <a:rPr lang="en-US" smtClean="0"/>
              <a:t> </a:t>
            </a:r>
            <a:r>
              <a:rPr lang="en-US" smtClean="0"/>
              <a:t>seedlings</a:t>
            </a:r>
            <a:r>
              <a:rPr lang="en-US" dirty="0" smtClean="0"/>
              <a:t>. The white circles represent the application of essential oils or the compounds. The arrows show the direction in which the essential oils or the compounds move when cover slip is placed on the samples</a:t>
            </a:r>
            <a:endParaRPr lang="en-US" dirty="0"/>
          </a:p>
        </p:txBody>
      </p:sp>
    </p:spTree>
    <p:extLst>
      <p:ext uri="{BB962C8B-B14F-4D97-AF65-F5344CB8AC3E}">
        <p14:creationId xmlns:p14="http://schemas.microsoft.com/office/powerpoint/2010/main" val="384597859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67</Words>
  <Application>Microsoft Macintosh PowerPoint</Application>
  <PresentationFormat>Widescreen</PresentationFormat>
  <Paragraphs>8</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Calibri</vt:lpstr>
      <vt:lpstr>Calibri Light</vt:lpstr>
      <vt:lpstr>Arial</vt:lpstr>
      <vt:lpstr>Office Theme</vt:lpstr>
      <vt:lpstr>PowerPoint Presentation</vt:lpstr>
    </vt:vector>
  </TitlesOfParts>
  <Company/>
  <LinksUpToDate>false</LinksUpToDate>
  <SharedDoc>false</SharedDoc>
  <HyperlinksChanged>false</HyperlinksChanged>
  <AppVersion>15.003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orker</dc:creator>
  <cp:lastModifiedBy>Microsoft Office User</cp:lastModifiedBy>
  <cp:revision>9</cp:revision>
  <dcterms:created xsi:type="dcterms:W3CDTF">2020-05-19T17:47:42Z</dcterms:created>
  <dcterms:modified xsi:type="dcterms:W3CDTF">2020-06-22T22:22:40Z</dcterms:modified>
</cp:coreProperties>
</file>